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33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tiff"/><Relationship Id="rId8" Type="http://schemas.openxmlformats.org/officeDocument/2006/relationships/image" Target="../media/image7.jpeg"/><Relationship Id="rId9" Type="http://schemas.microsoft.com/office/2007/relationships/hdphoto" Target="../media/hdphoto1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図 140"/>
          <p:cNvPicPr>
            <a:picLocks noChangeAspect="1"/>
          </p:cNvPicPr>
          <p:nvPr/>
        </p:nvPicPr>
        <p:blipFill>
          <a:blip r:embed="rId2"/>
          <a:srcRect t="10630"/>
          <a:stretch>
            <a:fillRect/>
          </a:stretch>
        </p:blipFill>
        <p:spPr>
          <a:xfrm>
            <a:off x="3876237" y="4981850"/>
            <a:ext cx="1857756" cy="1203099"/>
          </a:xfrm>
          <a:prstGeom prst="rect">
            <a:avLst/>
          </a:prstGeom>
        </p:spPr>
      </p:pic>
      <p:pic>
        <p:nvPicPr>
          <p:cNvPr id="104" name="図 103"/>
          <p:cNvPicPr>
            <a:picLocks noChangeAspect="1"/>
          </p:cNvPicPr>
          <p:nvPr/>
        </p:nvPicPr>
        <p:blipFill>
          <a:blip r:embed="rId3"/>
          <a:srcRect t="10630" r="22713"/>
          <a:stretch>
            <a:fillRect/>
          </a:stretch>
        </p:blipFill>
        <p:spPr>
          <a:xfrm>
            <a:off x="904964" y="4980103"/>
            <a:ext cx="811538" cy="1203099"/>
          </a:xfrm>
          <a:prstGeom prst="rect">
            <a:avLst/>
          </a:prstGeom>
        </p:spPr>
      </p:pic>
      <p:pic>
        <p:nvPicPr>
          <p:cNvPr id="102" name="図 101"/>
          <p:cNvPicPr>
            <a:picLocks noChangeAspect="1"/>
          </p:cNvPicPr>
          <p:nvPr/>
        </p:nvPicPr>
        <p:blipFill>
          <a:blip r:embed="rId4"/>
          <a:srcRect t="10630" r="16433"/>
          <a:stretch>
            <a:fillRect/>
          </a:stretch>
        </p:blipFill>
        <p:spPr>
          <a:xfrm>
            <a:off x="1793658" y="4980103"/>
            <a:ext cx="1940587" cy="1203099"/>
          </a:xfrm>
          <a:prstGeom prst="rect">
            <a:avLst/>
          </a:prstGeom>
        </p:spPr>
      </p:pic>
      <p:sp>
        <p:nvSpPr>
          <p:cNvPr id="62" name="テキスト ボックス 61"/>
          <p:cNvSpPr txBox="1"/>
          <p:nvPr/>
        </p:nvSpPr>
        <p:spPr>
          <a:xfrm>
            <a:off x="819487" y="438987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5013632" y="6230276"/>
            <a:ext cx="384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CA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65171" y="7222905"/>
            <a:ext cx="647999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3.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rd1 </a:t>
            </a:r>
            <a:r>
              <a:rPr lang="en-US" altLang="ja-JP" sz="1200" b="1" i="1" dirty="0">
                <a:solidFill>
                  <a:srgbClr val="000000"/>
                </a:solidFill>
                <a:latin typeface="Times New Roman"/>
                <a:cs typeface="Times New Roman"/>
              </a:rPr>
              <a:t>promoter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-driven EGFP expression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in </a:t>
            </a:r>
            <a:r>
              <a:rPr lang="ja-JP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</a:t>
            </a:r>
            <a:r>
              <a:rPr lang="en-US" altLang="ja-JP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ubregions</a:t>
            </a:r>
            <a:r>
              <a:rPr lang="ja-JP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of</a:t>
            </a:r>
            <a:r>
              <a:rPr lang="ja-JP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the</a:t>
            </a:r>
            <a:r>
              <a:rPr lang="ja-JP" altLang="en-US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entate</a:t>
            </a:r>
            <a:r>
              <a:rPr lang="ja-JP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gyrus</a:t>
            </a:r>
            <a:r>
              <a:rPr lang="ja-JP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nd</a:t>
            </a:r>
            <a:r>
              <a:rPr lang="ja-JP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CA1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EGFP expression in the dentate gyrus and CA1 i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fluoxetine (FLX; 15 mg/kg/day for 14 days) or placebo (PL) pellet-treated [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Drd1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]-EGFP mice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cale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bars, 100 µm. </a:t>
            </a:r>
            <a:r>
              <a:rPr lang="de-DE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de-DE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b</a:t>
            </a:r>
            <a:r>
              <a:rPr lang="de-DE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Higher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magnification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of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the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pyramdal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cell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layer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(SP) in </a:t>
            </a:r>
            <a:r>
              <a:rPr lang="de-DE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the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CA1.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cale bars, 50 µm.</a:t>
            </a:r>
            <a:r>
              <a:rPr lang="de-DE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c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The number of EGFP-positive cells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n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ubregion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of the dentate gyrus (DG) and CA1 was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counted.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d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A fluorescence signal of EGFP in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subregions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of the dentate gyrus (DG) and CA1 was quantified using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ImageJ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 The fluorescent signal obtained in the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subregions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of wild-type mice was subtracted as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background. Data represent Mean ± S.E.M. 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5, 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0.01, *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0.00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vs. the placebo group; Student’s 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t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test. The number of mice is indicated in parentheses under each experimental condition.</a:t>
            </a:r>
            <a:r>
              <a:rPr lang="ja-JP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O,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tratum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oriens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;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P,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tratum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pyramidale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;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R,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tratum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radiatum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;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LM,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tratum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lacunosum-moleculare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;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L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molecular layer; GC, granule cell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layer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4522613" y="60531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M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240203" y="60531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G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4361585" y="62302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DG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131" name="直線コネクタ 130"/>
          <p:cNvCxnSpPr/>
          <p:nvPr/>
        </p:nvCxnSpPr>
        <p:spPr>
          <a:xfrm>
            <a:off x="4295082" y="6258896"/>
            <a:ext cx="510033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>
            <a:off x="4316285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4192578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4595076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4472762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4872333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4751656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5149332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5026586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5426255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5303730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103" name="直線コネクタ 102"/>
          <p:cNvCxnSpPr/>
          <p:nvPr/>
        </p:nvCxnSpPr>
        <p:spPr>
          <a:xfrm>
            <a:off x="4850987" y="6258896"/>
            <a:ext cx="759423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/>
          <p:cNvSpPr txBox="1"/>
          <p:nvPr/>
        </p:nvSpPr>
        <p:spPr>
          <a:xfrm>
            <a:off x="4766618" y="6053157"/>
            <a:ext cx="3956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L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5359825" y="6053157"/>
            <a:ext cx="32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P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5078112" y="6053157"/>
            <a:ext cx="3271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R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4309959" y="5024143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**</a:t>
            </a:r>
            <a:endParaRPr lang="ja-JP" altLang="en-US" sz="1200" dirty="0" smtClean="0">
              <a:latin typeface="Arial"/>
              <a:cs typeface="Arial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4618255" y="5097647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grpSp>
        <p:nvGrpSpPr>
          <p:cNvPr id="2" name="図形グループ 119"/>
          <p:cNvGrpSpPr/>
          <p:nvPr/>
        </p:nvGrpSpPr>
        <p:grpSpPr>
          <a:xfrm>
            <a:off x="5445642" y="4890230"/>
            <a:ext cx="399226" cy="367946"/>
            <a:chOff x="2956036" y="2863001"/>
            <a:chExt cx="399226" cy="367946"/>
          </a:xfrm>
        </p:grpSpPr>
        <p:sp>
          <p:nvSpPr>
            <p:cNvPr id="67" name="正方形/長方形 66"/>
            <p:cNvSpPr>
              <a:spLocks noChangeAspect="1"/>
            </p:cNvSpPr>
            <p:nvPr/>
          </p:nvSpPr>
          <p:spPr>
            <a:xfrm>
              <a:off x="2956036" y="2944945"/>
              <a:ext cx="67154" cy="67154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正方形/長方形 67"/>
            <p:cNvSpPr>
              <a:spLocks noChangeAspect="1"/>
            </p:cNvSpPr>
            <p:nvPr/>
          </p:nvSpPr>
          <p:spPr>
            <a:xfrm>
              <a:off x="2956036" y="3085234"/>
              <a:ext cx="67154" cy="67154"/>
            </a:xfrm>
            <a:prstGeom prst="rect">
              <a:avLst/>
            </a:prstGeom>
            <a:solidFill>
              <a:srgbClr val="CBEFFE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2958925" y="2863001"/>
              <a:ext cx="3258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PL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2958925" y="3000115"/>
              <a:ext cx="3963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smtClean="0">
                  <a:latin typeface="Arial"/>
                  <a:cs typeface="Arial"/>
                </a:rPr>
                <a:t>FLX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</p:grpSp>
      <p:sp>
        <p:nvSpPr>
          <p:cNvPr id="151" name="テキスト ボックス 150"/>
          <p:cNvSpPr txBox="1"/>
          <p:nvPr/>
        </p:nvSpPr>
        <p:spPr>
          <a:xfrm>
            <a:off x="1405677" y="4979693"/>
            <a:ext cx="364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***</a:t>
            </a:r>
            <a:endParaRPr lang="ja-JP" altLang="en-US" sz="1200" dirty="0" smtClean="0">
              <a:latin typeface="Arial"/>
              <a:cs typeface="Arial"/>
            </a:endParaRPr>
          </a:p>
        </p:txBody>
      </p:sp>
      <p:pic>
        <p:nvPicPr>
          <p:cNvPr id="82" name="図 81" descr="Drd1 EGFP_FLX_180521.jp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 flipH="1">
            <a:off x="1532101" y="2345283"/>
            <a:ext cx="1760280" cy="2347040"/>
          </a:xfrm>
          <a:prstGeom prst="rect">
            <a:avLst/>
          </a:prstGeom>
        </p:spPr>
      </p:pic>
      <p:pic>
        <p:nvPicPr>
          <p:cNvPr id="76" name="図 75" descr="Drd1 EGFP_PL_180521.jpg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6200000" flipH="1">
            <a:off x="1532102" y="551545"/>
            <a:ext cx="1760279" cy="2347039"/>
          </a:xfrm>
          <a:prstGeom prst="rect">
            <a:avLst/>
          </a:prstGeom>
        </p:spPr>
      </p:pic>
      <p:cxnSp>
        <p:nvCxnSpPr>
          <p:cNvPr id="31" name="직선 연결선 22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509079FD-E9EA-4EB8-85AD-A576DC74E908}"/>
              </a:ext>
            </a:extLst>
          </p:cNvPr>
          <p:cNvCxnSpPr>
            <a:cxnSpLocks/>
          </p:cNvCxnSpPr>
          <p:nvPr/>
        </p:nvCxnSpPr>
        <p:spPr>
          <a:xfrm>
            <a:off x="3292341" y="2502863"/>
            <a:ext cx="219744" cy="1384"/>
          </a:xfrm>
          <a:prstGeom prst="line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26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A2374926-BE67-429F-BE21-C47810119961}"/>
              </a:ext>
            </a:extLst>
          </p:cNvPr>
          <p:cNvSpPr txBox="1"/>
          <p:nvPr/>
        </p:nvSpPr>
        <p:spPr>
          <a:xfrm>
            <a:off x="1672478" y="1155152"/>
            <a:ext cx="3196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27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99411B74-14AE-4323-BE3C-FB3F8CD5B76C}"/>
              </a:ext>
            </a:extLst>
          </p:cNvPr>
          <p:cNvSpPr txBox="1"/>
          <p:nvPr/>
        </p:nvSpPr>
        <p:spPr>
          <a:xfrm>
            <a:off x="1811383" y="1372322"/>
            <a:ext cx="3271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28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D9446A1E-0B4A-40C2-847F-C2B1907B4A44}"/>
              </a:ext>
            </a:extLst>
          </p:cNvPr>
          <p:cNvSpPr txBox="1"/>
          <p:nvPr/>
        </p:nvSpPr>
        <p:spPr>
          <a:xfrm>
            <a:off x="1936629" y="1590158"/>
            <a:ext cx="3956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M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29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2D9F57AD-76DB-4160-B9DB-A6EA8699A738}"/>
              </a:ext>
            </a:extLst>
          </p:cNvPr>
          <p:cNvSpPr txBox="1"/>
          <p:nvPr/>
        </p:nvSpPr>
        <p:spPr>
          <a:xfrm>
            <a:off x="2118441" y="1816420"/>
            <a:ext cx="295219" cy="1878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0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</a:ext>
            </a:extLst>
          </p:cNvPr>
          <p:cNvSpPr txBox="1"/>
          <p:nvPr/>
        </p:nvSpPr>
        <p:spPr>
          <a:xfrm>
            <a:off x="2195920" y="2011692"/>
            <a:ext cx="369024" cy="2348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1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A2374926-BE67-429F-BE21-C47810119961}"/>
              </a:ext>
            </a:extLst>
          </p:cNvPr>
          <p:cNvSpPr txBox="1"/>
          <p:nvPr/>
        </p:nvSpPr>
        <p:spPr>
          <a:xfrm>
            <a:off x="1657229" y="2796279"/>
            <a:ext cx="3196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2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99411B74-14AE-4323-BE3C-FB3F8CD5B76C}"/>
              </a:ext>
            </a:extLst>
          </p:cNvPr>
          <p:cNvSpPr txBox="1"/>
          <p:nvPr/>
        </p:nvSpPr>
        <p:spPr>
          <a:xfrm>
            <a:off x="1796136" y="3013449"/>
            <a:ext cx="3271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3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D9446A1E-0B4A-40C2-847F-C2B1907B4A44}"/>
              </a:ext>
            </a:extLst>
          </p:cNvPr>
          <p:cNvSpPr txBox="1"/>
          <p:nvPr/>
        </p:nvSpPr>
        <p:spPr>
          <a:xfrm>
            <a:off x="1921380" y="3225882"/>
            <a:ext cx="3956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M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34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2D9F57AD-76DB-4160-B9DB-A6EA8699A738}"/>
              </a:ext>
            </a:extLst>
          </p:cNvPr>
          <p:cNvSpPr txBox="1"/>
          <p:nvPr/>
        </p:nvSpPr>
        <p:spPr>
          <a:xfrm>
            <a:off x="2103193" y="3457547"/>
            <a:ext cx="295219" cy="1878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35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</a:ext>
            </a:extLst>
          </p:cNvPr>
          <p:cNvSpPr txBox="1"/>
          <p:nvPr/>
        </p:nvSpPr>
        <p:spPr>
          <a:xfrm>
            <a:off x="2180672" y="3652819"/>
            <a:ext cx="369024" cy="2348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</a:t>
            </a:r>
            <a:endParaRPr lang="ko-KR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연결선 22">
            <a:extLst>
              <a:ext uri="{FF2B5EF4-FFF2-40B4-BE49-F238E27FC236}">
                <a16:creationId xmlns="" xmlns:a16="http://schemas.microsoft.com/office/drawing/2014/main" xmlns:mv="urn:schemas-microsoft-com:mac:vml" xmlns:mc="http://schemas.openxmlformats.org/markup-compatibility/2006" id="{509079FD-E9EA-4EB8-85AD-A576DC74E908}"/>
              </a:ext>
            </a:extLst>
          </p:cNvPr>
          <p:cNvCxnSpPr>
            <a:cxnSpLocks/>
          </p:cNvCxnSpPr>
          <p:nvPr/>
        </p:nvCxnSpPr>
        <p:spPr>
          <a:xfrm>
            <a:off x="3325612" y="4331207"/>
            <a:ext cx="219744" cy="1384"/>
          </a:xfrm>
          <a:prstGeom prst="line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 rot="16200000">
            <a:off x="886308" y="1587890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PL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 rot="16200000">
            <a:off x="841373" y="3382055"/>
            <a:ext cx="466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FLX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819487" y="450054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err="1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grpSp>
        <p:nvGrpSpPr>
          <p:cNvPr id="3" name="図形グループ 104"/>
          <p:cNvGrpSpPr>
            <a:grpSpLocks noChangeAspect="1"/>
          </p:cNvGrpSpPr>
          <p:nvPr/>
        </p:nvGrpSpPr>
        <p:grpSpPr>
          <a:xfrm>
            <a:off x="4030724" y="844925"/>
            <a:ext cx="1775136" cy="1760400"/>
            <a:chOff x="3412567" y="817023"/>
            <a:chExt cx="1803151" cy="1788182"/>
          </a:xfrm>
        </p:grpSpPr>
        <p:pic>
          <p:nvPicPr>
            <p:cNvPr id="115" name="그림 14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8FF26C78-F8CC-4316-B90B-A05E9181C41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2567" y="817023"/>
              <a:ext cx="1803151" cy="1788182"/>
            </a:xfrm>
            <a:prstGeom prst="rect">
              <a:avLst/>
            </a:prstGeom>
          </p:spPr>
        </p:pic>
        <p:cxnSp>
          <p:nvCxnSpPr>
            <p:cNvPr id="116" name="직선 연결선 22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509079FD-E9EA-4EB8-85AD-A576DC74E908}"/>
                </a:ext>
              </a:extLst>
            </p:cNvPr>
            <p:cNvCxnSpPr>
              <a:cxnSpLocks/>
            </p:cNvCxnSpPr>
            <p:nvPr/>
          </p:nvCxnSpPr>
          <p:spPr>
            <a:xfrm>
              <a:off x="4879384" y="2496747"/>
              <a:ext cx="277305" cy="1168"/>
            </a:xfrm>
            <a:prstGeom prst="line">
              <a:avLst/>
            </a:prstGeom>
            <a:ln w="12700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3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  </a:ext>
              </a:extLst>
            </p:cNvPr>
            <p:cNvSpPr txBox="1"/>
            <p:nvPr/>
          </p:nvSpPr>
          <p:spPr>
            <a:xfrm>
              <a:off x="3430751" y="1549190"/>
              <a:ext cx="3328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3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  </a:ext>
              </a:extLst>
            </p:cNvPr>
            <p:cNvSpPr txBox="1"/>
            <p:nvPr/>
          </p:nvSpPr>
          <p:spPr>
            <a:xfrm>
              <a:off x="3664093" y="1917714"/>
              <a:ext cx="3196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3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  </a:ext>
              </a:extLst>
            </p:cNvPr>
            <p:cNvSpPr txBox="1"/>
            <p:nvPr/>
          </p:nvSpPr>
          <p:spPr>
            <a:xfrm>
              <a:off x="3932838" y="2241564"/>
              <a:ext cx="327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R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図形グループ 106"/>
          <p:cNvGrpSpPr>
            <a:grpSpLocks noChangeAspect="1"/>
          </p:cNvGrpSpPr>
          <p:nvPr/>
        </p:nvGrpSpPr>
        <p:grpSpPr>
          <a:xfrm>
            <a:off x="4027810" y="2638662"/>
            <a:ext cx="1775137" cy="1760400"/>
            <a:chOff x="3412566" y="2751323"/>
            <a:chExt cx="1803152" cy="1788182"/>
          </a:xfrm>
        </p:grpSpPr>
        <p:pic>
          <p:nvPicPr>
            <p:cNvPr id="114" name="그림 8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75B92FE0-9935-4887-9837-26EB2D1BF8F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2566" y="2751323"/>
              <a:ext cx="1803152" cy="1788182"/>
            </a:xfrm>
            <a:prstGeom prst="rect">
              <a:avLst/>
            </a:prstGeom>
          </p:spPr>
        </p:pic>
        <p:cxnSp>
          <p:nvCxnSpPr>
            <p:cNvPr id="117" name="직선 연결선 22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509079FD-E9EA-4EB8-85AD-A576DC74E908}"/>
                </a:ext>
              </a:extLst>
            </p:cNvPr>
            <p:cNvCxnSpPr>
              <a:cxnSpLocks/>
            </p:cNvCxnSpPr>
            <p:nvPr/>
          </p:nvCxnSpPr>
          <p:spPr>
            <a:xfrm>
              <a:off x="4860505" y="4431047"/>
              <a:ext cx="277305" cy="1168"/>
            </a:xfrm>
            <a:prstGeom prst="line">
              <a:avLst/>
            </a:prstGeom>
            <a:ln w="12700" cap="flat" cmpd="sng" algn="ctr">
              <a:solidFill>
                <a:schemeClr val="bg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3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  </a:ext>
              </a:extLst>
            </p:cNvPr>
            <p:cNvSpPr txBox="1"/>
            <p:nvPr/>
          </p:nvSpPr>
          <p:spPr>
            <a:xfrm>
              <a:off x="3415481" y="3483490"/>
              <a:ext cx="3328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3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  </a:ext>
              </a:extLst>
            </p:cNvPr>
            <p:cNvSpPr txBox="1"/>
            <p:nvPr/>
          </p:nvSpPr>
          <p:spPr>
            <a:xfrm>
              <a:off x="3648823" y="3852014"/>
              <a:ext cx="3196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3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F7067B80-1E20-4C41-A628-8AD2D6D1ABCF}"/>
                </a:ext>
              </a:extLst>
            </p:cNvPr>
            <p:cNvSpPr txBox="1"/>
            <p:nvPr/>
          </p:nvSpPr>
          <p:spPr>
            <a:xfrm>
              <a:off x="3917568" y="4175864"/>
              <a:ext cx="327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R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0" name="テキスト ボックス 129"/>
          <p:cNvSpPr txBox="1"/>
          <p:nvPr/>
        </p:nvSpPr>
        <p:spPr>
          <a:xfrm>
            <a:off x="3671271" y="4500547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err="1" smtClean="0">
                <a:latin typeface="Arial Bold"/>
                <a:cs typeface="Arial Bold"/>
              </a:rPr>
              <a:t>d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 rot="16200000">
            <a:off x="3673988" y="1587890"/>
            <a:ext cx="377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PL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 rot="16200000">
            <a:off x="3629053" y="3382055"/>
            <a:ext cx="466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FLX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3671271" y="438987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2240455" y="60531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M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2234105" y="62302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DG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113" name="直線コネクタ 112"/>
          <p:cNvCxnSpPr/>
          <p:nvPr/>
        </p:nvCxnSpPr>
        <p:spPr>
          <a:xfrm>
            <a:off x="2288984" y="6258896"/>
            <a:ext cx="227257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8" name="テキスト ボックス 117"/>
          <p:cNvSpPr txBox="1"/>
          <p:nvPr/>
        </p:nvSpPr>
        <p:spPr>
          <a:xfrm>
            <a:off x="2909230" y="6230276"/>
            <a:ext cx="384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CA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119" name="直線コネクタ 118"/>
          <p:cNvCxnSpPr/>
          <p:nvPr/>
        </p:nvCxnSpPr>
        <p:spPr>
          <a:xfrm>
            <a:off x="2572035" y="6258896"/>
            <a:ext cx="1058631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テキスト ボックス 119"/>
          <p:cNvSpPr txBox="1"/>
          <p:nvPr/>
        </p:nvSpPr>
        <p:spPr>
          <a:xfrm>
            <a:off x="2487666" y="6053157"/>
            <a:ext cx="3956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L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3080873" y="6053157"/>
            <a:ext cx="32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P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2799160" y="6053157"/>
            <a:ext cx="3271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R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3357759" y="6053157"/>
            <a:ext cx="3328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O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2316603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2192896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2595394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2473080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2872651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2751974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3149650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3026904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3426573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3304048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1352594" y="605315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G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1352594" y="623027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DG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155" name="直線コネクタ 154"/>
          <p:cNvCxnSpPr/>
          <p:nvPr/>
        </p:nvCxnSpPr>
        <p:spPr>
          <a:xfrm>
            <a:off x="1407473" y="6258896"/>
            <a:ext cx="227257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6" name="テキスト ボックス 155"/>
          <p:cNvSpPr txBox="1"/>
          <p:nvPr/>
        </p:nvSpPr>
        <p:spPr>
          <a:xfrm>
            <a:off x="1432975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1298797" y="638304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(3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1635920" y="4635847"/>
            <a:ext cx="13035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EGFP-positive cell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4441781" y="4635847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EGFP intensity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grpSp>
        <p:nvGrpSpPr>
          <p:cNvPr id="107" name="図形グループ 119"/>
          <p:cNvGrpSpPr/>
          <p:nvPr/>
        </p:nvGrpSpPr>
        <p:grpSpPr>
          <a:xfrm>
            <a:off x="3358247" y="4890230"/>
            <a:ext cx="399226" cy="367946"/>
            <a:chOff x="2956036" y="2863001"/>
            <a:chExt cx="399226" cy="367946"/>
          </a:xfrm>
        </p:grpSpPr>
        <p:sp>
          <p:nvSpPr>
            <p:cNvPr id="110" name="正方形/長方形 109"/>
            <p:cNvSpPr>
              <a:spLocks noChangeAspect="1"/>
            </p:cNvSpPr>
            <p:nvPr/>
          </p:nvSpPr>
          <p:spPr>
            <a:xfrm>
              <a:off x="2956036" y="2944945"/>
              <a:ext cx="67154" cy="67154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7" name="正方形/長方形 136"/>
            <p:cNvSpPr>
              <a:spLocks noChangeAspect="1"/>
            </p:cNvSpPr>
            <p:nvPr/>
          </p:nvSpPr>
          <p:spPr>
            <a:xfrm>
              <a:off x="2956036" y="3085234"/>
              <a:ext cx="67154" cy="67154"/>
            </a:xfrm>
            <a:prstGeom prst="rect">
              <a:avLst/>
            </a:prstGeom>
            <a:solidFill>
              <a:srgbClr val="CBEFFE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8" name="テキスト ボックス 137"/>
            <p:cNvSpPr txBox="1"/>
            <p:nvPr/>
          </p:nvSpPr>
          <p:spPr>
            <a:xfrm>
              <a:off x="2958925" y="2863001"/>
              <a:ext cx="3258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smtClean="0">
                  <a:latin typeface="Arial"/>
                  <a:cs typeface="Arial"/>
                </a:rPr>
                <a:t>PL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39" name="テキスト ボックス 138"/>
            <p:cNvSpPr txBox="1"/>
            <p:nvPr/>
          </p:nvSpPr>
          <p:spPr>
            <a:xfrm>
              <a:off x="2958925" y="3000115"/>
              <a:ext cx="3963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smtClean="0">
                  <a:latin typeface="Arial"/>
                  <a:cs typeface="Arial"/>
                </a:rPr>
                <a:t>FLX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</p:grpSp>
      <p:sp>
        <p:nvSpPr>
          <p:cNvPr id="105" name="テキスト ボックス 104"/>
          <p:cNvSpPr txBox="1"/>
          <p:nvPr/>
        </p:nvSpPr>
        <p:spPr>
          <a:xfrm>
            <a:off x="1599068" y="567926"/>
            <a:ext cx="1604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d</a:t>
            </a:r>
            <a:r>
              <a:rPr kumimoji="1" lang="en-US" altLang="ja-JP" sz="1200" dirty="0" smtClean="0">
                <a:latin typeface="Arial"/>
                <a:cs typeface="Arial"/>
              </a:rPr>
              <a:t>entate gyrus &amp; CA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4669221" y="567926"/>
            <a:ext cx="4840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CA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361</Words>
  <Application>Microsoft Macintosh PowerPoint</Application>
  <PresentationFormat>A4 210x297 mm</PresentationFormat>
  <Paragraphs>7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29:03Z</dcterms:modified>
  <cp:category/>
</cp:coreProperties>
</file>